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2760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3615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763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1353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6148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382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895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1064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451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397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9501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852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29E74-0E6E-4698-A02D-5689739E2117}" type="datetimeFigureOut">
              <a:rPr kumimoji="1" lang="ja-JP" altLang="en-US" smtClean="0"/>
              <a:t>2024/4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F0463A-9E3F-4F25-92F8-92A76854D3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698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2" Type="http://schemas.openxmlformats.org/officeDocument/2006/relationships/image" Target="../media/image19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TI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コンピューターに表示された文字&#10;&#10;中程度の精度で自動的に生成された説明">
            <a:extLst>
              <a:ext uri="{FF2B5EF4-FFF2-40B4-BE49-F238E27FC236}">
                <a16:creationId xmlns:a16="http://schemas.microsoft.com/office/drawing/2014/main" id="{F18E33A0-205F-74EA-C6E2-0302FDF462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6" t="17325" r="8652" b="20655"/>
          <a:stretch/>
        </p:blipFill>
        <p:spPr>
          <a:xfrm>
            <a:off x="875489" y="688535"/>
            <a:ext cx="5107022" cy="2735602"/>
          </a:xfrm>
          <a:prstGeom prst="rect">
            <a:avLst/>
          </a:prstGeom>
        </p:spPr>
      </p:pic>
      <p:pic>
        <p:nvPicPr>
          <p:cNvPr id="5" name="図 4" descr="コンピューターの画面&#10;&#10;自動的に生成された説明">
            <a:extLst>
              <a:ext uri="{FF2B5EF4-FFF2-40B4-BE49-F238E27FC236}">
                <a16:creationId xmlns:a16="http://schemas.microsoft.com/office/drawing/2014/main" id="{3EA0BD4E-CCE8-A68C-D5C9-C85721CF423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36" t="24945" r="6666" b="14736"/>
          <a:stretch/>
        </p:blipFill>
        <p:spPr>
          <a:xfrm>
            <a:off x="875489" y="3585198"/>
            <a:ext cx="5107022" cy="277238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DA243E-2ABF-79B6-4C67-B7A137F1EC9F}"/>
              </a:ext>
            </a:extLst>
          </p:cNvPr>
          <p:cNvSpPr txBox="1"/>
          <p:nvPr/>
        </p:nvSpPr>
        <p:spPr>
          <a:xfrm>
            <a:off x="0" y="-121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CE8542D-2B0B-877A-A8A4-0966CF31D73E}"/>
              </a:ext>
            </a:extLst>
          </p:cNvPr>
          <p:cNvSpPr txBox="1"/>
          <p:nvPr/>
        </p:nvSpPr>
        <p:spPr>
          <a:xfrm>
            <a:off x="138381" y="68853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1387174-09B9-A766-F7BE-87A8DDCBCD40}"/>
              </a:ext>
            </a:extLst>
          </p:cNvPr>
          <p:cNvSpPr txBox="1"/>
          <p:nvPr/>
        </p:nvSpPr>
        <p:spPr>
          <a:xfrm>
            <a:off x="1031133" y="668502"/>
            <a:ext cx="5037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 M  1   2   3   4   5   6   7   8   9  10  11 12 13 14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59DAD21-1170-C1A3-51C4-39CB639C3E93}"/>
              </a:ext>
            </a:extLst>
          </p:cNvPr>
          <p:cNvSpPr txBox="1"/>
          <p:nvPr/>
        </p:nvSpPr>
        <p:spPr>
          <a:xfrm>
            <a:off x="961016" y="3621243"/>
            <a:ext cx="4945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15 16 17 18  19 20 21 22 23 24 25 26 27 28 29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 descr="コンピューターの画面&#10;&#10;自動的に生成された説明">
            <a:extLst>
              <a:ext uri="{FF2B5EF4-FFF2-40B4-BE49-F238E27FC236}">
                <a16:creationId xmlns:a16="http://schemas.microsoft.com/office/drawing/2014/main" id="{393DE585-20CF-333B-4E4C-AA8C044CD7E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79" t="23746" r="33789" b="14030"/>
          <a:stretch/>
        </p:blipFill>
        <p:spPr>
          <a:xfrm>
            <a:off x="875489" y="6518642"/>
            <a:ext cx="2493177" cy="2785247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4DCCA11-F1F3-462E-1A8C-831F95FE9AB1}"/>
              </a:ext>
            </a:extLst>
          </p:cNvPr>
          <p:cNvSpPr txBox="1"/>
          <p:nvPr/>
        </p:nvSpPr>
        <p:spPr>
          <a:xfrm>
            <a:off x="875489" y="6604392"/>
            <a:ext cx="2547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30 31 32 33 34 35 36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16289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座る, コンピュータ, テーブル, モニター が含まれている画像&#10;&#10;自動的に生成された説明">
            <a:extLst>
              <a:ext uri="{FF2B5EF4-FFF2-40B4-BE49-F238E27FC236}">
                <a16:creationId xmlns:a16="http://schemas.microsoft.com/office/drawing/2014/main" id="{B4BC70A5-298C-9BB9-3FC0-027CF220A88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2" t="16418" r="7376" b="19151"/>
          <a:stretch/>
        </p:blipFill>
        <p:spPr>
          <a:xfrm>
            <a:off x="996485" y="584770"/>
            <a:ext cx="5107022" cy="286264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C61139C-934F-DFA4-A81C-4F56F7E45DDA}"/>
              </a:ext>
            </a:extLst>
          </p:cNvPr>
          <p:cNvSpPr txBox="1"/>
          <p:nvPr/>
        </p:nvSpPr>
        <p:spPr>
          <a:xfrm>
            <a:off x="138381" y="68853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B78418F-F309-BB51-089E-4FE131788FF5}"/>
              </a:ext>
            </a:extLst>
          </p:cNvPr>
          <p:cNvSpPr txBox="1"/>
          <p:nvPr/>
        </p:nvSpPr>
        <p:spPr>
          <a:xfrm>
            <a:off x="1031133" y="668502"/>
            <a:ext cx="5037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 M  1   2   3   4   5   6   7   8   9  10  11 12 13 14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 descr="白黒の写真にテキストが書いてある｜｜｜ｐ&#10;&#10;低い精度で自動的に生成された説明">
            <a:extLst>
              <a:ext uri="{FF2B5EF4-FFF2-40B4-BE49-F238E27FC236}">
                <a16:creationId xmlns:a16="http://schemas.microsoft.com/office/drawing/2014/main" id="{2143C274-CA9B-88A1-8314-1A8C4714FC4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7" t="17647" r="7517" b="19311"/>
          <a:stretch/>
        </p:blipFill>
        <p:spPr>
          <a:xfrm>
            <a:off x="1012099" y="3651651"/>
            <a:ext cx="5107022" cy="2710735"/>
          </a:xfrm>
          <a:prstGeom prst="rect">
            <a:avLst/>
          </a:prstGeom>
        </p:spPr>
      </p:pic>
      <p:pic>
        <p:nvPicPr>
          <p:cNvPr id="9" name="図 8" descr="座る, コンピュータ, モニター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AE97A749-A444-DA72-272F-098C1EE8595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82" t="19679" r="37447" b="18171"/>
          <a:stretch/>
        </p:blipFill>
        <p:spPr>
          <a:xfrm>
            <a:off x="1012098" y="6526763"/>
            <a:ext cx="2584685" cy="2862642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4CBD5B0-FE8A-F4A1-A93F-B7144858AB59}"/>
              </a:ext>
            </a:extLst>
          </p:cNvPr>
          <p:cNvSpPr txBox="1"/>
          <p:nvPr/>
        </p:nvSpPr>
        <p:spPr>
          <a:xfrm>
            <a:off x="1077203" y="3651651"/>
            <a:ext cx="4945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15 16 17 18  19 20 21 22 23 24 25 26 27 28 29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8D4B056-79A3-3A4F-5B22-77F75E81ECD6}"/>
              </a:ext>
            </a:extLst>
          </p:cNvPr>
          <p:cNvSpPr txBox="1"/>
          <p:nvPr/>
        </p:nvSpPr>
        <p:spPr>
          <a:xfrm>
            <a:off x="1018118" y="6566625"/>
            <a:ext cx="2547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30 31 32 33 34 35 36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0789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 descr="白黒の写真にテキストが書いてある｜｜｜ｐ&#10;&#10;低い精度で自動的に生成された説明">
            <a:extLst>
              <a:ext uri="{FF2B5EF4-FFF2-40B4-BE49-F238E27FC236}">
                <a16:creationId xmlns:a16="http://schemas.microsoft.com/office/drawing/2014/main" id="{B0FD8467-D1EF-46E7-7608-8492D0CDEAD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12" t="19603" r="33616" b="16585"/>
          <a:stretch/>
        </p:blipFill>
        <p:spPr>
          <a:xfrm>
            <a:off x="886522" y="6350830"/>
            <a:ext cx="2548894" cy="2540251"/>
          </a:xfrm>
          <a:prstGeom prst="rect">
            <a:avLst/>
          </a:prstGeom>
        </p:spPr>
      </p:pic>
      <p:pic>
        <p:nvPicPr>
          <p:cNvPr id="12" name="図 11" descr="白黒の写真&#10;&#10;中程度の精度で自動的に生成された説明">
            <a:extLst>
              <a:ext uri="{FF2B5EF4-FFF2-40B4-BE49-F238E27FC236}">
                <a16:creationId xmlns:a16="http://schemas.microsoft.com/office/drawing/2014/main" id="{73E11D3F-8097-35E7-D33A-79358773EB0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50" t="18228" r="8226" b="18228"/>
          <a:stretch/>
        </p:blipFill>
        <p:spPr>
          <a:xfrm>
            <a:off x="886522" y="3447370"/>
            <a:ext cx="5084955" cy="2751357"/>
          </a:xfrm>
          <a:prstGeom prst="rect">
            <a:avLst/>
          </a:prstGeom>
        </p:spPr>
      </p:pic>
      <p:pic>
        <p:nvPicPr>
          <p:cNvPr id="10" name="図 9" descr="コンピューターの画面&#10;&#10;自動的に生成された説明">
            <a:extLst>
              <a:ext uri="{FF2B5EF4-FFF2-40B4-BE49-F238E27FC236}">
                <a16:creationId xmlns:a16="http://schemas.microsoft.com/office/drawing/2014/main" id="{B417D5FC-844E-CC99-1E8E-789ED8F17B0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43" t="19198" r="6666" b="19197"/>
          <a:stretch/>
        </p:blipFill>
        <p:spPr>
          <a:xfrm>
            <a:off x="886522" y="680587"/>
            <a:ext cx="5084955" cy="261468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242EEAD-0835-94AA-4A6C-AC07DDFB87A4}"/>
              </a:ext>
            </a:extLst>
          </p:cNvPr>
          <p:cNvSpPr txBox="1"/>
          <p:nvPr/>
        </p:nvSpPr>
        <p:spPr>
          <a:xfrm>
            <a:off x="138381" y="68853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AEBDD6D-8ECD-DDF5-FF1D-7D8F9CFA5588}"/>
              </a:ext>
            </a:extLst>
          </p:cNvPr>
          <p:cNvSpPr txBox="1"/>
          <p:nvPr/>
        </p:nvSpPr>
        <p:spPr>
          <a:xfrm>
            <a:off x="1031133" y="668502"/>
            <a:ext cx="5037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 M  1   2   3   4   5   6   7   8   9  10  11 12 13 14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02C6F4B-5D31-CFCC-E176-E96F1928D20F}"/>
              </a:ext>
            </a:extLst>
          </p:cNvPr>
          <p:cNvSpPr txBox="1"/>
          <p:nvPr/>
        </p:nvSpPr>
        <p:spPr>
          <a:xfrm>
            <a:off x="979821" y="3447370"/>
            <a:ext cx="4945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15 16 17 18  19 20 21 22 23 24 25 26 27 28 29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738952E-F5AF-09C6-9D9C-A76E904487A6}"/>
              </a:ext>
            </a:extLst>
          </p:cNvPr>
          <p:cNvSpPr txBox="1"/>
          <p:nvPr/>
        </p:nvSpPr>
        <p:spPr>
          <a:xfrm>
            <a:off x="924818" y="6420710"/>
            <a:ext cx="2547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30 31 32 33 34 35 36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57325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座る, コンピュータ, ノートパソコン, モニター が含まれている画像&#10;&#10;自動的に生成された説明">
            <a:extLst>
              <a:ext uri="{FF2B5EF4-FFF2-40B4-BE49-F238E27FC236}">
                <a16:creationId xmlns:a16="http://schemas.microsoft.com/office/drawing/2014/main" id="{7039DDBC-2C79-EFEF-D911-00AC96F9DC2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90" t="22383" r="30354" b="14752"/>
          <a:stretch/>
        </p:blipFill>
        <p:spPr>
          <a:xfrm>
            <a:off x="873950" y="6407458"/>
            <a:ext cx="2555050" cy="2787225"/>
          </a:xfrm>
          <a:prstGeom prst="rect">
            <a:avLst/>
          </a:prstGeom>
        </p:spPr>
      </p:pic>
      <p:pic>
        <p:nvPicPr>
          <p:cNvPr id="9" name="図 8" descr="座る, モニター, 写真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1D332421-BE7C-DFEE-E55B-9C17F8A74BB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25" t="19598" r="7943" b="16271"/>
          <a:stretch/>
        </p:blipFill>
        <p:spPr>
          <a:xfrm>
            <a:off x="835212" y="3659610"/>
            <a:ext cx="5054820" cy="2643913"/>
          </a:xfrm>
          <a:prstGeom prst="rect">
            <a:avLst/>
          </a:prstGeom>
        </p:spPr>
      </p:pic>
      <p:pic>
        <p:nvPicPr>
          <p:cNvPr id="7" name="図 6" descr="座る, コンピュータ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3ABFE099-ADDF-3DE6-D3F3-2CC55743B89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24" t="17996" r="8369" b="21086"/>
          <a:stretch/>
        </p:blipFill>
        <p:spPr>
          <a:xfrm>
            <a:off x="835212" y="794962"/>
            <a:ext cx="5037726" cy="270358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BDBFF20-F6BD-FB77-B3AC-39FABA17D51F}"/>
              </a:ext>
            </a:extLst>
          </p:cNvPr>
          <p:cNvSpPr txBox="1"/>
          <p:nvPr/>
        </p:nvSpPr>
        <p:spPr>
          <a:xfrm>
            <a:off x="138381" y="68853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BB9E177-75C6-705F-801A-65D16F6E7FF7}"/>
              </a:ext>
            </a:extLst>
          </p:cNvPr>
          <p:cNvSpPr txBox="1"/>
          <p:nvPr/>
        </p:nvSpPr>
        <p:spPr>
          <a:xfrm>
            <a:off x="985062" y="794962"/>
            <a:ext cx="5037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 M  1   2   3   4   5   6   7   8   9  10  11 12 13 14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9D9FC3A-E205-8098-B98E-AB5E1F204A93}"/>
              </a:ext>
            </a:extLst>
          </p:cNvPr>
          <p:cNvSpPr txBox="1"/>
          <p:nvPr/>
        </p:nvSpPr>
        <p:spPr>
          <a:xfrm>
            <a:off x="854727" y="3710052"/>
            <a:ext cx="4945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15 16 17 18  19 20 21 22 23 24 25 26 27 28 29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7190D42-E4D7-A296-00EB-8936EA36DF9B}"/>
              </a:ext>
            </a:extLst>
          </p:cNvPr>
          <p:cNvSpPr txBox="1"/>
          <p:nvPr/>
        </p:nvSpPr>
        <p:spPr>
          <a:xfrm>
            <a:off x="816240" y="6481121"/>
            <a:ext cx="2547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30 31 32 33 34 35 36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57522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屋内, 写真, モニター, 座る が含まれている画像&#10;&#10;自動的に生成された説明">
            <a:extLst>
              <a:ext uri="{FF2B5EF4-FFF2-40B4-BE49-F238E27FC236}">
                <a16:creationId xmlns:a16="http://schemas.microsoft.com/office/drawing/2014/main" id="{A5F8A3CA-FFB5-14DE-A34E-F7D1E932DAA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68" t="28148" r="35603" b="11003"/>
          <a:stretch/>
        </p:blipFill>
        <p:spPr>
          <a:xfrm>
            <a:off x="978584" y="6685204"/>
            <a:ext cx="2540784" cy="2628040"/>
          </a:xfrm>
          <a:prstGeom prst="rect">
            <a:avLst/>
          </a:prstGeom>
        </p:spPr>
      </p:pic>
      <p:pic>
        <p:nvPicPr>
          <p:cNvPr id="10" name="図 9" descr="コンピューターの画面&#10;&#10;自動的に生成された説明">
            <a:extLst>
              <a:ext uri="{FF2B5EF4-FFF2-40B4-BE49-F238E27FC236}">
                <a16:creationId xmlns:a16="http://schemas.microsoft.com/office/drawing/2014/main" id="{D0377981-5AF6-F4A6-ED92-831CC7AC1B6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8" t="23358" r="7376" b="12534"/>
          <a:stretch/>
        </p:blipFill>
        <p:spPr>
          <a:xfrm>
            <a:off x="979819" y="3714840"/>
            <a:ext cx="4945585" cy="2753179"/>
          </a:xfrm>
          <a:prstGeom prst="rect">
            <a:avLst/>
          </a:prstGeom>
        </p:spPr>
      </p:pic>
      <p:pic>
        <p:nvPicPr>
          <p:cNvPr id="8" name="図 7" descr="コンピューターのスクリーンショット&#10;&#10;自動的に生成された説明">
            <a:extLst>
              <a:ext uri="{FF2B5EF4-FFF2-40B4-BE49-F238E27FC236}">
                <a16:creationId xmlns:a16="http://schemas.microsoft.com/office/drawing/2014/main" id="{B927BA2F-6C10-F514-9E09-29DADEE150C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4" t="28265" r="9220" b="8362"/>
          <a:stretch/>
        </p:blipFill>
        <p:spPr>
          <a:xfrm>
            <a:off x="979820" y="688305"/>
            <a:ext cx="4945585" cy="288334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5768C0-1F55-614F-D27F-4DD5B2741A9D}"/>
              </a:ext>
            </a:extLst>
          </p:cNvPr>
          <p:cNvSpPr txBox="1"/>
          <p:nvPr/>
        </p:nvSpPr>
        <p:spPr>
          <a:xfrm>
            <a:off x="138381" y="68853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3D4952D-BC3A-512D-F5E0-32A9BEA9ED0C}"/>
              </a:ext>
            </a:extLst>
          </p:cNvPr>
          <p:cNvSpPr txBox="1"/>
          <p:nvPr/>
        </p:nvSpPr>
        <p:spPr>
          <a:xfrm>
            <a:off x="1031133" y="668502"/>
            <a:ext cx="5037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 M  1   2   3   4   5   6   7   8   9  10  11 12 13 14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827F86D-D3A3-F49E-0052-B19CAE646DB2}"/>
              </a:ext>
            </a:extLst>
          </p:cNvPr>
          <p:cNvSpPr txBox="1"/>
          <p:nvPr/>
        </p:nvSpPr>
        <p:spPr>
          <a:xfrm>
            <a:off x="1046576" y="3788834"/>
            <a:ext cx="4945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15 16 17 18  19 20 21 22 23 24 25 26 27 28 29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7E7D61-148B-8858-F7FE-584E2E1C50F9}"/>
              </a:ext>
            </a:extLst>
          </p:cNvPr>
          <p:cNvSpPr txBox="1"/>
          <p:nvPr/>
        </p:nvSpPr>
        <p:spPr>
          <a:xfrm>
            <a:off x="971876" y="6685204"/>
            <a:ext cx="2547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30 31 32 33 34 35 36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41768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座る, 写真, コンピュータ, モニター が含まれている画像&#10;&#10;自動的に生成された説明">
            <a:extLst>
              <a:ext uri="{FF2B5EF4-FFF2-40B4-BE49-F238E27FC236}">
                <a16:creationId xmlns:a16="http://schemas.microsoft.com/office/drawing/2014/main" id="{98D5B3F6-5ED1-771E-D49A-798516500AB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04" t="19415" r="33475" b="18732"/>
          <a:stretch/>
        </p:blipFill>
        <p:spPr>
          <a:xfrm>
            <a:off x="954434" y="6688445"/>
            <a:ext cx="2595562" cy="2834627"/>
          </a:xfrm>
          <a:prstGeom prst="rect">
            <a:avLst/>
          </a:prstGeom>
        </p:spPr>
      </p:pic>
      <p:pic>
        <p:nvPicPr>
          <p:cNvPr id="9" name="図 8" descr="モニター画面に映る文字&#10;&#10;自動的に生成された説明">
            <a:extLst>
              <a:ext uri="{FF2B5EF4-FFF2-40B4-BE49-F238E27FC236}">
                <a16:creationId xmlns:a16="http://schemas.microsoft.com/office/drawing/2014/main" id="{13F763DC-77B7-9A60-F7B6-7687AF04D65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1" t="16717" r="7234" b="18738"/>
          <a:stretch/>
        </p:blipFill>
        <p:spPr>
          <a:xfrm>
            <a:off x="954434" y="3701347"/>
            <a:ext cx="5106821" cy="2813440"/>
          </a:xfrm>
          <a:prstGeom prst="rect">
            <a:avLst/>
          </a:prstGeom>
        </p:spPr>
      </p:pic>
      <p:pic>
        <p:nvPicPr>
          <p:cNvPr id="7" name="図 6" descr="白黒の写真に文字が入っている&#10;&#10;低い精度で自動的に生成された説明">
            <a:extLst>
              <a:ext uri="{FF2B5EF4-FFF2-40B4-BE49-F238E27FC236}">
                <a16:creationId xmlns:a16="http://schemas.microsoft.com/office/drawing/2014/main" id="{CE929D8D-C50C-55E1-D01F-8F9F2E5D74D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2" t="17445" r="8227" b="19354"/>
          <a:stretch/>
        </p:blipFill>
        <p:spPr>
          <a:xfrm>
            <a:off x="954434" y="641756"/>
            <a:ext cx="5037727" cy="2885933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844FF25-C9CB-A2CE-A6BE-75D3592E91A5}"/>
              </a:ext>
            </a:extLst>
          </p:cNvPr>
          <p:cNvSpPr txBox="1"/>
          <p:nvPr/>
        </p:nvSpPr>
        <p:spPr>
          <a:xfrm>
            <a:off x="138381" y="688535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6F980B2-397D-15BC-B818-208745FA9186}"/>
              </a:ext>
            </a:extLst>
          </p:cNvPr>
          <p:cNvSpPr txBox="1"/>
          <p:nvPr/>
        </p:nvSpPr>
        <p:spPr>
          <a:xfrm>
            <a:off x="1031133" y="668502"/>
            <a:ext cx="5037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 M  1   2   3   4   5   6   7   8   9  10  11 12 13 14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358E48C-ED90-CCF2-E0BF-768FDAB25BEB}"/>
              </a:ext>
            </a:extLst>
          </p:cNvPr>
          <p:cNvSpPr txBox="1"/>
          <p:nvPr/>
        </p:nvSpPr>
        <p:spPr>
          <a:xfrm>
            <a:off x="1081124" y="3790455"/>
            <a:ext cx="4945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15 16 17 18  19 20 21 22 23 24 25 26 27 28 29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D42B16F-3B94-4F13-C80A-32C7DCC3466D}"/>
              </a:ext>
            </a:extLst>
          </p:cNvPr>
          <p:cNvSpPr txBox="1"/>
          <p:nvPr/>
        </p:nvSpPr>
        <p:spPr>
          <a:xfrm>
            <a:off x="954434" y="6779642"/>
            <a:ext cx="2547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30 31 32 33 34 35 36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56577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 descr="コンピューターの画面&#10;&#10;自動的に生成された説明">
            <a:extLst>
              <a:ext uri="{FF2B5EF4-FFF2-40B4-BE49-F238E27FC236}">
                <a16:creationId xmlns:a16="http://schemas.microsoft.com/office/drawing/2014/main" id="{50193FE1-A474-DC2D-9AE5-486CC847F0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61" t="15786" r="7815" b="20013"/>
          <a:stretch/>
        </p:blipFill>
        <p:spPr>
          <a:xfrm>
            <a:off x="917265" y="3584263"/>
            <a:ext cx="4972027" cy="2923261"/>
          </a:xfrm>
          <a:prstGeom prst="rect">
            <a:avLst/>
          </a:prstGeom>
        </p:spPr>
      </p:pic>
      <p:pic>
        <p:nvPicPr>
          <p:cNvPr id="16" name="図 15" descr="座る, 写真, モニター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11D76A48-FA9F-6C11-59EE-6B9B891959F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79" t="19028" r="32766" b="17755"/>
          <a:stretch/>
        </p:blipFill>
        <p:spPr>
          <a:xfrm>
            <a:off x="943706" y="6706563"/>
            <a:ext cx="2626438" cy="2811637"/>
          </a:xfrm>
          <a:prstGeom prst="rect">
            <a:avLst/>
          </a:prstGeom>
        </p:spPr>
      </p:pic>
      <p:pic>
        <p:nvPicPr>
          <p:cNvPr id="12" name="図 11" descr="モニター, 写真, 座る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B04CD814-D517-3249-B768-EBE47A9E947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99" t="22077" r="9788" b="15908"/>
          <a:stretch/>
        </p:blipFill>
        <p:spPr>
          <a:xfrm>
            <a:off x="943706" y="623189"/>
            <a:ext cx="4945586" cy="276203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844FF25-C9CB-A2CE-A6BE-75D3592E91A5}"/>
              </a:ext>
            </a:extLst>
          </p:cNvPr>
          <p:cNvSpPr txBox="1"/>
          <p:nvPr/>
        </p:nvSpPr>
        <p:spPr>
          <a:xfrm>
            <a:off x="138381" y="688535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6F980B2-397D-15BC-B818-208745FA9186}"/>
              </a:ext>
            </a:extLst>
          </p:cNvPr>
          <p:cNvSpPr txBox="1"/>
          <p:nvPr/>
        </p:nvSpPr>
        <p:spPr>
          <a:xfrm>
            <a:off x="1031133" y="668502"/>
            <a:ext cx="50377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  M  1   2   3   4   5   6   7   8   9  10  11 12 13 14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358E48C-ED90-CCF2-E0BF-768FDAB25BEB}"/>
              </a:ext>
            </a:extLst>
          </p:cNvPr>
          <p:cNvSpPr txBox="1"/>
          <p:nvPr/>
        </p:nvSpPr>
        <p:spPr>
          <a:xfrm>
            <a:off x="917265" y="3672678"/>
            <a:ext cx="4945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15 16 17 18  19 20 21 22 23 24 25 26 27 28 29 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D42B16F-3B94-4F13-C80A-32C7DCC3466D}"/>
              </a:ext>
            </a:extLst>
          </p:cNvPr>
          <p:cNvSpPr txBox="1"/>
          <p:nvPr/>
        </p:nvSpPr>
        <p:spPr>
          <a:xfrm>
            <a:off x="954434" y="6779642"/>
            <a:ext cx="25474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 30 31 32 33 34 35 36 P</a:t>
            </a:r>
            <a:endParaRPr kumimoji="1" lang="ja-JP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16121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D48927A-52E3-A1A4-7AAA-06D06D7521E1}"/>
              </a:ext>
            </a:extLst>
          </p:cNvPr>
          <p:cNvSpPr txBox="1"/>
          <p:nvPr/>
        </p:nvSpPr>
        <p:spPr>
          <a:xfrm>
            <a:off x="228623" y="714193"/>
            <a:ext cx="640075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CR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sults using each primer with the DNAs of Hemiptera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group, which parasitizes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us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</a:t>
            </a:r>
            <a:r>
              <a:rPr lang="en-US" altLang="ja-JP" sz="1200" i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urraya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rees.</a:t>
            </a:r>
            <a:r>
              <a:rPr lang="en-US" altLang="ja-JP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NA was extracted from the Hemiptera small insect group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used as a template for PCR using each primer. The list of the group and the corresponding sample DNA of each </a:t>
            </a:r>
            <a:r>
              <a:rPr lang="en-US" altLang="ja-JP" sz="1200" kern="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s in Suppl. Table 2. The targets of (A) Dc12s, (B)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cCOI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(C)DcND4 are the mitochondrial genome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The target of (D)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l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lbachia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p., that of (E)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P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olbachia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age, that of (F) Car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rsonell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p., and that of (G</a:t>
            </a:r>
            <a:r>
              <a:rPr lang="en-US" altLang="ja-JP" sz="1200" kern="10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Pro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fftell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p. Each template is as follows, Lane 1 to 36: The Hemiptera group; N: water (negative control); P: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sitivi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ntrol); M: 100 bp ladder marker. Lanes 29 and 30 are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 collected at different times and locations than that of the positive control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7239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56</TotalTime>
  <Words>522</Words>
  <Application>Microsoft Office PowerPoint</Application>
  <PresentationFormat>A4 210 x 297 mm</PresentationFormat>
  <Paragraphs>30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4</cp:revision>
  <dcterms:created xsi:type="dcterms:W3CDTF">2024-04-05T09:44:38Z</dcterms:created>
  <dcterms:modified xsi:type="dcterms:W3CDTF">2024-04-15T07:06:24Z</dcterms:modified>
</cp:coreProperties>
</file>